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E0DD30-2509-49B1-94A5-8B14B6DBFFCD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3403F7-9B00-4E1A-8383-16161AF025E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46083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 smtClean="0"/>
          </a:p>
        </p:txBody>
      </p:sp>
      <p:sp>
        <p:nvSpPr>
          <p:cNvPr id="46084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4CA7F0D3-E7EB-461F-B4A8-7F7329C5F5A7}" type="slidenum">
              <a:rPr lang="en-US" smtClean="0"/>
              <a:pPr/>
              <a:t>1</a:t>
            </a:fld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E1BC8-A658-43F9-99F7-A501DD40DA1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958B9-2AB2-43E4-9001-8EA0FCC170C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79"/>
          <p:cNvGrpSpPr>
            <a:grpSpLocks/>
          </p:cNvGrpSpPr>
          <p:nvPr/>
        </p:nvGrpSpPr>
        <p:grpSpPr bwMode="auto">
          <a:xfrm>
            <a:off x="685800" y="609600"/>
            <a:ext cx="7543800" cy="6096000"/>
            <a:chOff x="990600" y="152400"/>
            <a:chExt cx="8001000" cy="6629400"/>
          </a:xfrm>
        </p:grpSpPr>
        <p:grpSp>
          <p:nvGrpSpPr>
            <p:cNvPr id="3" name="Group 77"/>
            <p:cNvGrpSpPr>
              <a:grpSpLocks/>
            </p:cNvGrpSpPr>
            <p:nvPr/>
          </p:nvGrpSpPr>
          <p:grpSpPr bwMode="auto">
            <a:xfrm>
              <a:off x="990600" y="152400"/>
              <a:ext cx="8001000" cy="6629400"/>
              <a:chOff x="990600" y="152400"/>
              <a:chExt cx="8001000" cy="6629400"/>
            </a:xfrm>
          </p:grpSpPr>
          <p:sp>
            <p:nvSpPr>
              <p:cNvPr id="28678" name="Freeform 38"/>
              <p:cNvSpPr>
                <a:spLocks noEditPoints="1"/>
              </p:cNvSpPr>
              <p:nvPr/>
            </p:nvSpPr>
            <p:spPr bwMode="auto">
              <a:xfrm>
                <a:off x="990600" y="152400"/>
                <a:ext cx="8001000" cy="6629400"/>
              </a:xfrm>
              <a:custGeom>
                <a:avLst/>
                <a:gdLst>
                  <a:gd name="T0" fmla="*/ 0 w 17744"/>
                  <a:gd name="T1" fmla="*/ 2147483647 h 10112"/>
                  <a:gd name="T2" fmla="*/ 2147483647 w 17744"/>
                  <a:gd name="T3" fmla="*/ 0 h 10112"/>
                  <a:gd name="T4" fmla="*/ 2147483647 w 17744"/>
                  <a:gd name="T5" fmla="*/ 0 h 10112"/>
                  <a:gd name="T6" fmla="*/ 2147483647 w 17744"/>
                  <a:gd name="T7" fmla="*/ 2147483647 h 10112"/>
                  <a:gd name="T8" fmla="*/ 2147483647 w 17744"/>
                  <a:gd name="T9" fmla="*/ 2147483647 h 10112"/>
                  <a:gd name="T10" fmla="*/ 2147483647 w 17744"/>
                  <a:gd name="T11" fmla="*/ 2147483647 h 10112"/>
                  <a:gd name="T12" fmla="*/ 2147483647 w 17744"/>
                  <a:gd name="T13" fmla="*/ 2147483647 h 10112"/>
                  <a:gd name="T14" fmla="*/ 0 w 17744"/>
                  <a:gd name="T15" fmla="*/ 2147483647 h 10112"/>
                  <a:gd name="T16" fmla="*/ 0 w 17744"/>
                  <a:gd name="T17" fmla="*/ 2147483647 h 10112"/>
                  <a:gd name="T18" fmla="*/ 2147483647 w 17744"/>
                  <a:gd name="T19" fmla="*/ 2147483647 h 10112"/>
                  <a:gd name="T20" fmla="*/ 2147483647 w 17744"/>
                  <a:gd name="T21" fmla="*/ 2147483647 h 10112"/>
                  <a:gd name="T22" fmla="*/ 2147483647 w 17744"/>
                  <a:gd name="T23" fmla="*/ 2147483647 h 10112"/>
                  <a:gd name="T24" fmla="*/ 2147483647 w 17744"/>
                  <a:gd name="T25" fmla="*/ 2147483647 h 10112"/>
                  <a:gd name="T26" fmla="*/ 2147483647 w 17744"/>
                  <a:gd name="T27" fmla="*/ 2147483647 h 10112"/>
                  <a:gd name="T28" fmla="*/ 2147483647 w 17744"/>
                  <a:gd name="T29" fmla="*/ 2147483647 h 10112"/>
                  <a:gd name="T30" fmla="*/ 2147483647 w 17744"/>
                  <a:gd name="T31" fmla="*/ 2147483647 h 10112"/>
                  <a:gd name="T32" fmla="*/ 2147483647 w 17744"/>
                  <a:gd name="T33" fmla="*/ 2147483647 h 10112"/>
                  <a:gd name="T34" fmla="*/ 2147483647 w 17744"/>
                  <a:gd name="T35" fmla="*/ 2147483647 h 10112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17744"/>
                  <a:gd name="T55" fmla="*/ 0 h 10112"/>
                  <a:gd name="T56" fmla="*/ 17744 w 17744"/>
                  <a:gd name="T57" fmla="*/ 10112 h 10112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17744" h="1011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7736" y="0"/>
                    </a:lnTo>
                    <a:cubicBezTo>
                      <a:pt x="17741" y="0"/>
                      <a:pt x="17744" y="4"/>
                      <a:pt x="17744" y="8"/>
                    </a:cubicBezTo>
                    <a:lnTo>
                      <a:pt x="17744" y="10104"/>
                    </a:lnTo>
                    <a:cubicBezTo>
                      <a:pt x="17744" y="10109"/>
                      <a:pt x="17741" y="10112"/>
                      <a:pt x="17736" y="10112"/>
                    </a:cubicBezTo>
                    <a:lnTo>
                      <a:pt x="8" y="10112"/>
                    </a:lnTo>
                    <a:cubicBezTo>
                      <a:pt x="4" y="10112"/>
                      <a:pt x="0" y="10109"/>
                      <a:pt x="0" y="10104"/>
                    </a:cubicBezTo>
                    <a:lnTo>
                      <a:pt x="0" y="8"/>
                    </a:lnTo>
                    <a:close/>
                    <a:moveTo>
                      <a:pt x="16" y="10104"/>
                    </a:moveTo>
                    <a:lnTo>
                      <a:pt x="8" y="10096"/>
                    </a:lnTo>
                    <a:lnTo>
                      <a:pt x="17736" y="10096"/>
                    </a:lnTo>
                    <a:lnTo>
                      <a:pt x="17728" y="10104"/>
                    </a:lnTo>
                    <a:lnTo>
                      <a:pt x="17728" y="8"/>
                    </a:lnTo>
                    <a:lnTo>
                      <a:pt x="17736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0104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79" name="AutoShape 4"/>
              <p:cNvSpPr>
                <a:spLocks noChangeAspect="1" noChangeArrowheads="1" noTextEdit="1"/>
              </p:cNvSpPr>
              <p:nvPr/>
            </p:nvSpPr>
            <p:spPr bwMode="auto">
              <a:xfrm>
                <a:off x="1408113" y="528638"/>
                <a:ext cx="7389812" cy="35941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80" name="Rectangle 6"/>
              <p:cNvSpPr>
                <a:spLocks noChangeArrowheads="1"/>
              </p:cNvSpPr>
              <p:nvPr/>
            </p:nvSpPr>
            <p:spPr bwMode="auto">
              <a:xfrm>
                <a:off x="1411288" y="531813"/>
                <a:ext cx="7375525" cy="35814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81" name="Rectangle 27"/>
              <p:cNvSpPr>
                <a:spLocks noChangeArrowheads="1"/>
              </p:cNvSpPr>
              <p:nvPr/>
            </p:nvSpPr>
            <p:spPr bwMode="auto">
              <a:xfrm>
                <a:off x="2743200" y="228600"/>
                <a:ext cx="5156200" cy="4921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sz="1600">
                    <a:solidFill>
                      <a:srgbClr val="000000"/>
                    </a:solidFill>
                  </a:rPr>
                  <a:t>Serum from cord blood tested with intact and dissociated</a:t>
                </a:r>
              </a:p>
              <a:p>
                <a:pPr algn="ctr"/>
                <a:r>
                  <a:rPr lang="en-US" sz="1600">
                    <a:solidFill>
                      <a:srgbClr val="000000"/>
                    </a:solidFill>
                  </a:rPr>
                  <a:t>HLA class I single antigens</a:t>
                </a:r>
                <a:endParaRPr lang="en-US" sz="1600"/>
              </a:p>
            </p:txBody>
          </p:sp>
          <p:pic>
            <p:nvPicPr>
              <p:cNvPr id="28682" name="Picture 43" descr="Pos 73A&amp;77N white bkgrd dissociated.png"/>
              <p:cNvPicPr>
                <a:picLocks noChangeAspect="1"/>
              </p:cNvPicPr>
              <p:nvPr/>
            </p:nvPicPr>
            <p:blipFill>
              <a:blip r:embed="rId3" cstate="print"/>
              <a:srcRect l="30502" t="30000" r="31351" b="14444"/>
              <a:stretch>
                <a:fillRect/>
              </a:stretch>
            </p:blipFill>
            <p:spPr bwMode="auto">
              <a:xfrm>
                <a:off x="6486525" y="4495800"/>
                <a:ext cx="1600200" cy="18367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683" name="Picture 44" descr="Pos 73A&amp;77N white bkgrd intact.png"/>
              <p:cNvPicPr>
                <a:picLocks noChangeAspect="1"/>
              </p:cNvPicPr>
              <p:nvPr/>
            </p:nvPicPr>
            <p:blipFill>
              <a:blip r:embed="rId4" cstate="print"/>
              <a:srcRect l="27110" t="28889" r="31351" b="14444"/>
              <a:stretch>
                <a:fillRect/>
              </a:stretch>
            </p:blipFill>
            <p:spPr bwMode="auto">
              <a:xfrm>
                <a:off x="4121150" y="4424363"/>
                <a:ext cx="1871663" cy="20113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8684" name="Rectangle 35"/>
              <p:cNvSpPr>
                <a:spLocks noChangeArrowheads="1"/>
              </p:cNvSpPr>
              <p:nvPr/>
            </p:nvSpPr>
            <p:spPr bwMode="auto">
              <a:xfrm>
                <a:off x="3200400" y="4038600"/>
                <a:ext cx="3475038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800">
                    <a:solidFill>
                      <a:srgbClr val="000000"/>
                    </a:solidFill>
                  </a:rPr>
                  <a:t>Single Antigen Beads Specificities</a:t>
                </a:r>
                <a:endParaRPr lang="en-US" sz="1800"/>
              </a:p>
            </p:txBody>
          </p:sp>
          <p:sp>
            <p:nvSpPr>
              <p:cNvPr id="28685" name="TextBox 47"/>
              <p:cNvSpPr txBox="1">
                <a:spLocks noChangeArrowheads="1"/>
              </p:cNvSpPr>
              <p:nvPr/>
            </p:nvSpPr>
            <p:spPr bwMode="auto">
              <a:xfrm>
                <a:off x="4191000" y="6373813"/>
                <a:ext cx="1938338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400"/>
                  <a:t>Intact class I antigen</a:t>
                </a:r>
              </a:p>
            </p:txBody>
          </p:sp>
          <p:sp>
            <p:nvSpPr>
              <p:cNvPr id="28686" name="TextBox 48"/>
              <p:cNvSpPr txBox="1">
                <a:spLocks noChangeArrowheads="1"/>
              </p:cNvSpPr>
              <p:nvPr/>
            </p:nvSpPr>
            <p:spPr bwMode="auto">
              <a:xfrm>
                <a:off x="6348413" y="6350000"/>
                <a:ext cx="2105025" cy="2905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400"/>
                  <a:t>Dissociated class I antigen</a:t>
                </a:r>
              </a:p>
            </p:txBody>
          </p:sp>
          <p:sp>
            <p:nvSpPr>
              <p:cNvPr id="28687" name="TextBox 50"/>
              <p:cNvSpPr txBox="1">
                <a:spLocks noChangeArrowheads="1"/>
              </p:cNvSpPr>
              <p:nvPr/>
            </p:nvSpPr>
            <p:spPr bwMode="auto">
              <a:xfrm>
                <a:off x="6734175" y="4800600"/>
                <a:ext cx="609600" cy="5847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600">
                    <a:solidFill>
                      <a:schemeClr val="bg1"/>
                    </a:solidFill>
                  </a:rPr>
                  <a:t>77N</a:t>
                </a:r>
              </a:p>
              <a:p>
                <a:r>
                  <a:rPr lang="en-US" sz="1600">
                    <a:solidFill>
                      <a:schemeClr val="bg1"/>
                    </a:solidFill>
                  </a:rPr>
                  <a:t>73A</a:t>
                </a:r>
              </a:p>
            </p:txBody>
          </p:sp>
          <p:sp>
            <p:nvSpPr>
              <p:cNvPr id="28688" name="TextBox 56"/>
              <p:cNvSpPr txBox="1">
                <a:spLocks noChangeArrowheads="1"/>
              </p:cNvSpPr>
              <p:nvPr/>
            </p:nvSpPr>
            <p:spPr bwMode="auto">
              <a:xfrm rot="-4276723">
                <a:off x="4839494" y="5477669"/>
                <a:ext cx="698500" cy="2524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b="1">
                    <a:solidFill>
                      <a:schemeClr val="bg1"/>
                    </a:solidFill>
                  </a:rPr>
                  <a:t>Peptide</a:t>
                </a:r>
              </a:p>
            </p:txBody>
          </p:sp>
          <p:sp>
            <p:nvSpPr>
              <p:cNvPr id="28689" name="TextBox 57"/>
              <p:cNvSpPr txBox="1">
                <a:spLocks noChangeArrowheads="1"/>
              </p:cNvSpPr>
              <p:nvPr/>
            </p:nvSpPr>
            <p:spPr bwMode="auto">
              <a:xfrm>
                <a:off x="4513263" y="5786438"/>
                <a:ext cx="1122362" cy="2905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400" b="1">
                    <a:solidFill>
                      <a:schemeClr val="bg1"/>
                    </a:solidFill>
                  </a:rPr>
                  <a:t>Heavy chain</a:t>
                </a:r>
              </a:p>
            </p:txBody>
          </p:sp>
          <p:sp>
            <p:nvSpPr>
              <p:cNvPr id="28690" name="TextBox 58"/>
              <p:cNvSpPr txBox="1">
                <a:spLocks noChangeArrowheads="1"/>
              </p:cNvSpPr>
              <p:nvPr/>
            </p:nvSpPr>
            <p:spPr bwMode="auto">
              <a:xfrm rot="4334571">
                <a:off x="4248150" y="5541963"/>
                <a:ext cx="417513" cy="2809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l-GR" sz="1400" b="1">
                    <a:solidFill>
                      <a:schemeClr val="bg1"/>
                    </a:solidFill>
                  </a:rPr>
                  <a:t>β</a:t>
                </a:r>
                <a:r>
                  <a:rPr lang="en-US" sz="1400" b="1">
                    <a:solidFill>
                      <a:schemeClr val="bg1"/>
                    </a:solidFill>
                  </a:rPr>
                  <a:t>2 </a:t>
                </a:r>
              </a:p>
            </p:txBody>
          </p:sp>
          <p:sp>
            <p:nvSpPr>
              <p:cNvPr id="28691" name="TextBox 59"/>
              <p:cNvSpPr txBox="1">
                <a:spLocks noChangeArrowheads="1"/>
              </p:cNvSpPr>
              <p:nvPr/>
            </p:nvSpPr>
            <p:spPr bwMode="auto">
              <a:xfrm>
                <a:off x="6696075" y="5632450"/>
                <a:ext cx="1120775" cy="2889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400" b="1">
                    <a:solidFill>
                      <a:schemeClr val="bg1"/>
                    </a:solidFill>
                  </a:rPr>
                  <a:t>Heavy chain</a:t>
                </a:r>
              </a:p>
            </p:txBody>
          </p:sp>
          <p:sp>
            <p:nvSpPr>
              <p:cNvPr id="28692" name="Rectangle 33"/>
              <p:cNvSpPr>
                <a:spLocks noChangeArrowheads="1"/>
              </p:cNvSpPr>
              <p:nvPr/>
            </p:nvSpPr>
            <p:spPr bwMode="auto">
              <a:xfrm rot="16200000">
                <a:off x="-20415" y="2155776"/>
                <a:ext cx="2477453" cy="2937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r>
                  <a:rPr lang="en-US" sz="1800" dirty="0">
                    <a:solidFill>
                      <a:srgbClr val="000000"/>
                    </a:solidFill>
                  </a:rPr>
                  <a:t>Reaction </a:t>
                </a:r>
                <a:r>
                  <a:rPr lang="en-US" sz="1800" dirty="0" smtClean="0">
                    <a:solidFill>
                      <a:srgbClr val="000000"/>
                    </a:solidFill>
                  </a:rPr>
                  <a:t>strength (MFI)</a:t>
                </a:r>
                <a:endParaRPr lang="en-US" sz="1800" dirty="0"/>
              </a:p>
            </p:txBody>
          </p:sp>
          <p:sp>
            <p:nvSpPr>
              <p:cNvPr id="28693" name="Rectangle 7"/>
              <p:cNvSpPr>
                <a:spLocks noChangeArrowheads="1"/>
              </p:cNvSpPr>
              <p:nvPr/>
            </p:nvSpPr>
            <p:spPr bwMode="auto">
              <a:xfrm>
                <a:off x="1978025" y="1044575"/>
                <a:ext cx="6708775" cy="2614613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94" name="Freeform 8"/>
              <p:cNvSpPr>
                <a:spLocks noEditPoints="1"/>
              </p:cNvSpPr>
              <p:nvPr/>
            </p:nvSpPr>
            <p:spPr bwMode="auto">
              <a:xfrm>
                <a:off x="1981200" y="1044575"/>
                <a:ext cx="6708775" cy="2097088"/>
              </a:xfrm>
              <a:custGeom>
                <a:avLst/>
                <a:gdLst>
                  <a:gd name="T0" fmla="*/ 0 w 4629"/>
                  <a:gd name="T1" fmla="*/ 2147483647 h 1772"/>
                  <a:gd name="T2" fmla="*/ 2147483647 w 4629"/>
                  <a:gd name="T3" fmla="*/ 2147483647 h 1772"/>
                  <a:gd name="T4" fmla="*/ 2147483647 w 4629"/>
                  <a:gd name="T5" fmla="*/ 2147483647 h 1772"/>
                  <a:gd name="T6" fmla="*/ 0 w 4629"/>
                  <a:gd name="T7" fmla="*/ 2147483647 h 1772"/>
                  <a:gd name="T8" fmla="*/ 0 w 4629"/>
                  <a:gd name="T9" fmla="*/ 2147483647 h 1772"/>
                  <a:gd name="T10" fmla="*/ 0 w 4629"/>
                  <a:gd name="T11" fmla="*/ 2147483647 h 1772"/>
                  <a:gd name="T12" fmla="*/ 2147483647 w 4629"/>
                  <a:gd name="T13" fmla="*/ 2147483647 h 1772"/>
                  <a:gd name="T14" fmla="*/ 2147483647 w 4629"/>
                  <a:gd name="T15" fmla="*/ 2147483647 h 1772"/>
                  <a:gd name="T16" fmla="*/ 0 w 4629"/>
                  <a:gd name="T17" fmla="*/ 2147483647 h 1772"/>
                  <a:gd name="T18" fmla="*/ 0 w 4629"/>
                  <a:gd name="T19" fmla="*/ 2147483647 h 1772"/>
                  <a:gd name="T20" fmla="*/ 0 w 4629"/>
                  <a:gd name="T21" fmla="*/ 2147483647 h 1772"/>
                  <a:gd name="T22" fmla="*/ 2147483647 w 4629"/>
                  <a:gd name="T23" fmla="*/ 2147483647 h 1772"/>
                  <a:gd name="T24" fmla="*/ 2147483647 w 4629"/>
                  <a:gd name="T25" fmla="*/ 2147483647 h 1772"/>
                  <a:gd name="T26" fmla="*/ 0 w 4629"/>
                  <a:gd name="T27" fmla="*/ 2147483647 h 1772"/>
                  <a:gd name="T28" fmla="*/ 0 w 4629"/>
                  <a:gd name="T29" fmla="*/ 2147483647 h 1772"/>
                  <a:gd name="T30" fmla="*/ 0 w 4629"/>
                  <a:gd name="T31" fmla="*/ 2147483647 h 1772"/>
                  <a:gd name="T32" fmla="*/ 2147483647 w 4629"/>
                  <a:gd name="T33" fmla="*/ 2147483647 h 1772"/>
                  <a:gd name="T34" fmla="*/ 2147483647 w 4629"/>
                  <a:gd name="T35" fmla="*/ 2147483647 h 1772"/>
                  <a:gd name="T36" fmla="*/ 0 w 4629"/>
                  <a:gd name="T37" fmla="*/ 2147483647 h 1772"/>
                  <a:gd name="T38" fmla="*/ 0 w 4629"/>
                  <a:gd name="T39" fmla="*/ 2147483647 h 1772"/>
                  <a:gd name="T40" fmla="*/ 0 w 4629"/>
                  <a:gd name="T41" fmla="*/ 0 h 1772"/>
                  <a:gd name="T42" fmla="*/ 2147483647 w 4629"/>
                  <a:gd name="T43" fmla="*/ 0 h 1772"/>
                  <a:gd name="T44" fmla="*/ 2147483647 w 4629"/>
                  <a:gd name="T45" fmla="*/ 2147483647 h 1772"/>
                  <a:gd name="T46" fmla="*/ 0 w 4629"/>
                  <a:gd name="T47" fmla="*/ 2147483647 h 1772"/>
                  <a:gd name="T48" fmla="*/ 0 w 4629"/>
                  <a:gd name="T49" fmla="*/ 0 h 1772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4629"/>
                  <a:gd name="T76" fmla="*/ 0 h 1772"/>
                  <a:gd name="T77" fmla="*/ 4629 w 4629"/>
                  <a:gd name="T78" fmla="*/ 1772 h 1772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4629" h="1772">
                    <a:moveTo>
                      <a:pt x="0" y="1768"/>
                    </a:moveTo>
                    <a:lnTo>
                      <a:pt x="4629" y="1768"/>
                    </a:lnTo>
                    <a:lnTo>
                      <a:pt x="4629" y="1772"/>
                    </a:lnTo>
                    <a:lnTo>
                      <a:pt x="0" y="1772"/>
                    </a:lnTo>
                    <a:lnTo>
                      <a:pt x="0" y="1768"/>
                    </a:lnTo>
                    <a:close/>
                    <a:moveTo>
                      <a:pt x="0" y="1327"/>
                    </a:moveTo>
                    <a:lnTo>
                      <a:pt x="4629" y="1327"/>
                    </a:lnTo>
                    <a:lnTo>
                      <a:pt x="4629" y="1332"/>
                    </a:lnTo>
                    <a:lnTo>
                      <a:pt x="0" y="1332"/>
                    </a:lnTo>
                    <a:lnTo>
                      <a:pt x="0" y="1327"/>
                    </a:lnTo>
                    <a:close/>
                    <a:moveTo>
                      <a:pt x="0" y="882"/>
                    </a:moveTo>
                    <a:lnTo>
                      <a:pt x="4629" y="882"/>
                    </a:lnTo>
                    <a:lnTo>
                      <a:pt x="4629" y="886"/>
                    </a:lnTo>
                    <a:lnTo>
                      <a:pt x="0" y="886"/>
                    </a:lnTo>
                    <a:lnTo>
                      <a:pt x="0" y="882"/>
                    </a:lnTo>
                    <a:close/>
                    <a:moveTo>
                      <a:pt x="0" y="441"/>
                    </a:moveTo>
                    <a:lnTo>
                      <a:pt x="4629" y="441"/>
                    </a:lnTo>
                    <a:lnTo>
                      <a:pt x="4629" y="445"/>
                    </a:lnTo>
                    <a:lnTo>
                      <a:pt x="0" y="445"/>
                    </a:lnTo>
                    <a:lnTo>
                      <a:pt x="0" y="441"/>
                    </a:lnTo>
                    <a:close/>
                    <a:moveTo>
                      <a:pt x="0" y="0"/>
                    </a:moveTo>
                    <a:lnTo>
                      <a:pt x="4629" y="0"/>
                    </a:lnTo>
                    <a:lnTo>
                      <a:pt x="4629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5">
                <a:solidFill>
                  <a:srgbClr val="868686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95" name="Freeform 9"/>
              <p:cNvSpPr>
                <a:spLocks noEditPoints="1"/>
              </p:cNvSpPr>
              <p:nvPr/>
            </p:nvSpPr>
            <p:spPr bwMode="auto">
              <a:xfrm>
                <a:off x="2263775" y="2771775"/>
                <a:ext cx="5751513" cy="908050"/>
              </a:xfrm>
              <a:custGeom>
                <a:avLst/>
                <a:gdLst>
                  <a:gd name="T0" fmla="*/ 0 w 3968"/>
                  <a:gd name="T1" fmla="*/ 0 h 767"/>
                  <a:gd name="T2" fmla="*/ 2147483647 w 3968"/>
                  <a:gd name="T3" fmla="*/ 0 h 767"/>
                  <a:gd name="T4" fmla="*/ 2147483647 w 3968"/>
                  <a:gd name="T5" fmla="*/ 2147483647 h 767"/>
                  <a:gd name="T6" fmla="*/ 0 w 3968"/>
                  <a:gd name="T7" fmla="*/ 2147483647 h 767"/>
                  <a:gd name="T8" fmla="*/ 0 w 3968"/>
                  <a:gd name="T9" fmla="*/ 0 h 767"/>
                  <a:gd name="T10" fmla="*/ 2147483647 w 3968"/>
                  <a:gd name="T11" fmla="*/ 2147483647 h 767"/>
                  <a:gd name="T12" fmla="*/ 2147483647 w 3968"/>
                  <a:gd name="T13" fmla="*/ 2147483647 h 767"/>
                  <a:gd name="T14" fmla="*/ 2147483647 w 3968"/>
                  <a:gd name="T15" fmla="*/ 2147483647 h 767"/>
                  <a:gd name="T16" fmla="*/ 2147483647 w 3968"/>
                  <a:gd name="T17" fmla="*/ 2147483647 h 767"/>
                  <a:gd name="T18" fmla="*/ 2147483647 w 3968"/>
                  <a:gd name="T19" fmla="*/ 2147483647 h 767"/>
                  <a:gd name="T20" fmla="*/ 2147483647 w 3968"/>
                  <a:gd name="T21" fmla="*/ 2147483647 h 767"/>
                  <a:gd name="T22" fmla="*/ 2147483647 w 3968"/>
                  <a:gd name="T23" fmla="*/ 2147483647 h 767"/>
                  <a:gd name="T24" fmla="*/ 2147483647 w 3968"/>
                  <a:gd name="T25" fmla="*/ 2147483647 h 767"/>
                  <a:gd name="T26" fmla="*/ 2147483647 w 3968"/>
                  <a:gd name="T27" fmla="*/ 2147483647 h 767"/>
                  <a:gd name="T28" fmla="*/ 2147483647 w 3968"/>
                  <a:gd name="T29" fmla="*/ 2147483647 h 767"/>
                  <a:gd name="T30" fmla="*/ 2147483647 w 3968"/>
                  <a:gd name="T31" fmla="*/ 2147483647 h 767"/>
                  <a:gd name="T32" fmla="*/ 2147483647 w 3968"/>
                  <a:gd name="T33" fmla="*/ 2147483647 h 767"/>
                  <a:gd name="T34" fmla="*/ 2147483647 w 3968"/>
                  <a:gd name="T35" fmla="*/ 2147483647 h 767"/>
                  <a:gd name="T36" fmla="*/ 2147483647 w 3968"/>
                  <a:gd name="T37" fmla="*/ 2147483647 h 767"/>
                  <a:gd name="T38" fmla="*/ 2147483647 w 3968"/>
                  <a:gd name="T39" fmla="*/ 2147483647 h 767"/>
                  <a:gd name="T40" fmla="*/ 2147483647 w 3968"/>
                  <a:gd name="T41" fmla="*/ 2147483647 h 767"/>
                  <a:gd name="T42" fmla="*/ 2147483647 w 3968"/>
                  <a:gd name="T43" fmla="*/ 2147483647 h 767"/>
                  <a:gd name="T44" fmla="*/ 2147483647 w 3968"/>
                  <a:gd name="T45" fmla="*/ 2147483647 h 767"/>
                  <a:gd name="T46" fmla="*/ 2147483647 w 3968"/>
                  <a:gd name="T47" fmla="*/ 2147483647 h 767"/>
                  <a:gd name="T48" fmla="*/ 2147483647 w 3968"/>
                  <a:gd name="T49" fmla="*/ 2147483647 h 767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3968"/>
                  <a:gd name="T76" fmla="*/ 0 h 767"/>
                  <a:gd name="T77" fmla="*/ 3968 w 3968"/>
                  <a:gd name="T78" fmla="*/ 767 h 767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3968" h="767">
                    <a:moveTo>
                      <a:pt x="0" y="0"/>
                    </a:moveTo>
                    <a:lnTo>
                      <a:pt x="267" y="0"/>
                    </a:lnTo>
                    <a:lnTo>
                      <a:pt x="267" y="753"/>
                    </a:lnTo>
                    <a:lnTo>
                      <a:pt x="0" y="753"/>
                    </a:lnTo>
                    <a:lnTo>
                      <a:pt x="0" y="0"/>
                    </a:lnTo>
                    <a:close/>
                    <a:moveTo>
                      <a:pt x="928" y="308"/>
                    </a:moveTo>
                    <a:lnTo>
                      <a:pt x="1190" y="308"/>
                    </a:lnTo>
                    <a:lnTo>
                      <a:pt x="1190" y="753"/>
                    </a:lnTo>
                    <a:lnTo>
                      <a:pt x="928" y="753"/>
                    </a:lnTo>
                    <a:lnTo>
                      <a:pt x="928" y="308"/>
                    </a:lnTo>
                    <a:close/>
                    <a:moveTo>
                      <a:pt x="1851" y="505"/>
                    </a:moveTo>
                    <a:lnTo>
                      <a:pt x="2117" y="505"/>
                    </a:lnTo>
                    <a:lnTo>
                      <a:pt x="2117" y="753"/>
                    </a:lnTo>
                    <a:lnTo>
                      <a:pt x="1851" y="753"/>
                    </a:lnTo>
                    <a:lnTo>
                      <a:pt x="1851" y="505"/>
                    </a:lnTo>
                    <a:close/>
                    <a:moveTo>
                      <a:pt x="2779" y="611"/>
                    </a:moveTo>
                    <a:lnTo>
                      <a:pt x="3045" y="611"/>
                    </a:lnTo>
                    <a:lnTo>
                      <a:pt x="3045" y="753"/>
                    </a:lnTo>
                    <a:lnTo>
                      <a:pt x="2779" y="753"/>
                    </a:lnTo>
                    <a:lnTo>
                      <a:pt x="2779" y="611"/>
                    </a:lnTo>
                    <a:close/>
                    <a:moveTo>
                      <a:pt x="3706" y="753"/>
                    </a:moveTo>
                    <a:lnTo>
                      <a:pt x="3968" y="753"/>
                    </a:lnTo>
                    <a:lnTo>
                      <a:pt x="3968" y="767"/>
                    </a:lnTo>
                    <a:lnTo>
                      <a:pt x="3706" y="767"/>
                    </a:lnTo>
                    <a:lnTo>
                      <a:pt x="3706" y="753"/>
                    </a:lnTo>
                    <a:close/>
                  </a:path>
                </a:pathLst>
              </a:custGeom>
              <a:solidFill>
                <a:srgbClr val="C0000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96" name="Freeform 10"/>
              <p:cNvSpPr>
                <a:spLocks noEditPoints="1"/>
              </p:cNvSpPr>
              <p:nvPr/>
            </p:nvSpPr>
            <p:spPr bwMode="auto">
              <a:xfrm>
                <a:off x="2649538" y="1255713"/>
                <a:ext cx="5751512" cy="2403475"/>
              </a:xfrm>
              <a:custGeom>
                <a:avLst/>
                <a:gdLst>
                  <a:gd name="T0" fmla="*/ 0 w 3968"/>
                  <a:gd name="T1" fmla="*/ 0 h 2030"/>
                  <a:gd name="T2" fmla="*/ 2147483647 w 3968"/>
                  <a:gd name="T3" fmla="*/ 0 h 2030"/>
                  <a:gd name="T4" fmla="*/ 2147483647 w 3968"/>
                  <a:gd name="T5" fmla="*/ 2147483647 h 2030"/>
                  <a:gd name="T6" fmla="*/ 0 w 3968"/>
                  <a:gd name="T7" fmla="*/ 2147483647 h 2030"/>
                  <a:gd name="T8" fmla="*/ 0 w 3968"/>
                  <a:gd name="T9" fmla="*/ 0 h 2030"/>
                  <a:gd name="T10" fmla="*/ 2147483647 w 3968"/>
                  <a:gd name="T11" fmla="*/ 2147483647 h 2030"/>
                  <a:gd name="T12" fmla="*/ 2147483647 w 3968"/>
                  <a:gd name="T13" fmla="*/ 2147483647 h 2030"/>
                  <a:gd name="T14" fmla="*/ 2147483647 w 3968"/>
                  <a:gd name="T15" fmla="*/ 2147483647 h 2030"/>
                  <a:gd name="T16" fmla="*/ 2147483647 w 3968"/>
                  <a:gd name="T17" fmla="*/ 2147483647 h 2030"/>
                  <a:gd name="T18" fmla="*/ 2147483647 w 3968"/>
                  <a:gd name="T19" fmla="*/ 2147483647 h 2030"/>
                  <a:gd name="T20" fmla="*/ 2147483647 w 3968"/>
                  <a:gd name="T21" fmla="*/ 2147483647 h 2030"/>
                  <a:gd name="T22" fmla="*/ 2147483647 w 3968"/>
                  <a:gd name="T23" fmla="*/ 2147483647 h 2030"/>
                  <a:gd name="T24" fmla="*/ 2147483647 w 3968"/>
                  <a:gd name="T25" fmla="*/ 2147483647 h 2030"/>
                  <a:gd name="T26" fmla="*/ 2147483647 w 3968"/>
                  <a:gd name="T27" fmla="*/ 2147483647 h 2030"/>
                  <a:gd name="T28" fmla="*/ 2147483647 w 3968"/>
                  <a:gd name="T29" fmla="*/ 2147483647 h 2030"/>
                  <a:gd name="T30" fmla="*/ 2147483647 w 3968"/>
                  <a:gd name="T31" fmla="*/ 2147483647 h 2030"/>
                  <a:gd name="T32" fmla="*/ 2147483647 w 3968"/>
                  <a:gd name="T33" fmla="*/ 2147483647 h 2030"/>
                  <a:gd name="T34" fmla="*/ 2147483647 w 3968"/>
                  <a:gd name="T35" fmla="*/ 2147483647 h 2030"/>
                  <a:gd name="T36" fmla="*/ 2147483647 w 3968"/>
                  <a:gd name="T37" fmla="*/ 2147483647 h 2030"/>
                  <a:gd name="T38" fmla="*/ 2147483647 w 3968"/>
                  <a:gd name="T39" fmla="*/ 2147483647 h 2030"/>
                  <a:gd name="T40" fmla="*/ 2147483647 w 3968"/>
                  <a:gd name="T41" fmla="*/ 2147483647 h 2030"/>
                  <a:gd name="T42" fmla="*/ 2147483647 w 3968"/>
                  <a:gd name="T43" fmla="*/ 2147483647 h 2030"/>
                  <a:gd name="T44" fmla="*/ 2147483647 w 3968"/>
                  <a:gd name="T45" fmla="*/ 2147483647 h 2030"/>
                  <a:gd name="T46" fmla="*/ 2147483647 w 3968"/>
                  <a:gd name="T47" fmla="*/ 2147483647 h 2030"/>
                  <a:gd name="T48" fmla="*/ 2147483647 w 3968"/>
                  <a:gd name="T49" fmla="*/ 2147483647 h 2030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3968"/>
                  <a:gd name="T76" fmla="*/ 0 h 2030"/>
                  <a:gd name="T77" fmla="*/ 3968 w 3968"/>
                  <a:gd name="T78" fmla="*/ 2030 h 2030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3968" h="2030">
                    <a:moveTo>
                      <a:pt x="0" y="0"/>
                    </a:moveTo>
                    <a:lnTo>
                      <a:pt x="261" y="0"/>
                    </a:lnTo>
                    <a:lnTo>
                      <a:pt x="261" y="2030"/>
                    </a:lnTo>
                    <a:lnTo>
                      <a:pt x="0" y="2030"/>
                    </a:lnTo>
                    <a:lnTo>
                      <a:pt x="0" y="0"/>
                    </a:lnTo>
                    <a:close/>
                    <a:moveTo>
                      <a:pt x="923" y="634"/>
                    </a:moveTo>
                    <a:lnTo>
                      <a:pt x="1189" y="634"/>
                    </a:lnTo>
                    <a:lnTo>
                      <a:pt x="1189" y="2030"/>
                    </a:lnTo>
                    <a:lnTo>
                      <a:pt x="923" y="2030"/>
                    </a:lnTo>
                    <a:lnTo>
                      <a:pt x="923" y="634"/>
                    </a:lnTo>
                    <a:close/>
                    <a:moveTo>
                      <a:pt x="1850" y="951"/>
                    </a:moveTo>
                    <a:lnTo>
                      <a:pt x="2117" y="951"/>
                    </a:lnTo>
                    <a:lnTo>
                      <a:pt x="2117" y="2030"/>
                    </a:lnTo>
                    <a:lnTo>
                      <a:pt x="1850" y="2030"/>
                    </a:lnTo>
                    <a:lnTo>
                      <a:pt x="1850" y="951"/>
                    </a:lnTo>
                    <a:close/>
                    <a:moveTo>
                      <a:pt x="2778" y="624"/>
                    </a:moveTo>
                    <a:lnTo>
                      <a:pt x="3040" y="624"/>
                    </a:lnTo>
                    <a:lnTo>
                      <a:pt x="3040" y="2030"/>
                    </a:lnTo>
                    <a:lnTo>
                      <a:pt x="2778" y="2030"/>
                    </a:lnTo>
                    <a:lnTo>
                      <a:pt x="2778" y="624"/>
                    </a:lnTo>
                    <a:close/>
                    <a:moveTo>
                      <a:pt x="3701" y="1988"/>
                    </a:moveTo>
                    <a:lnTo>
                      <a:pt x="3968" y="1988"/>
                    </a:lnTo>
                    <a:lnTo>
                      <a:pt x="3968" y="2030"/>
                    </a:lnTo>
                    <a:lnTo>
                      <a:pt x="3701" y="2030"/>
                    </a:lnTo>
                    <a:lnTo>
                      <a:pt x="3701" y="1988"/>
                    </a:lnTo>
                    <a:close/>
                  </a:path>
                </a:pathLst>
              </a:custGeom>
              <a:solidFill>
                <a:srgbClr val="00B05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97" name="Rectangle 11"/>
              <p:cNvSpPr>
                <a:spLocks noChangeArrowheads="1"/>
              </p:cNvSpPr>
              <p:nvPr/>
            </p:nvSpPr>
            <p:spPr bwMode="auto">
              <a:xfrm>
                <a:off x="1978025" y="1046163"/>
                <a:ext cx="4763" cy="2614612"/>
              </a:xfrm>
              <a:prstGeom prst="rect">
                <a:avLst/>
              </a:prstGeom>
              <a:solidFill>
                <a:srgbClr val="868686"/>
              </a:solidFill>
              <a:ln w="5">
                <a:solidFill>
                  <a:srgbClr val="868686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en-US" sz="1400"/>
              </a:p>
            </p:txBody>
          </p:sp>
          <p:sp>
            <p:nvSpPr>
              <p:cNvPr id="28698" name="Freeform 12"/>
              <p:cNvSpPr>
                <a:spLocks noEditPoints="1"/>
              </p:cNvSpPr>
              <p:nvPr/>
            </p:nvSpPr>
            <p:spPr bwMode="auto">
              <a:xfrm>
                <a:off x="1933575" y="1044575"/>
                <a:ext cx="47625" cy="2619375"/>
              </a:xfrm>
              <a:custGeom>
                <a:avLst/>
                <a:gdLst>
                  <a:gd name="T0" fmla="*/ 0 w 32"/>
                  <a:gd name="T1" fmla="*/ 2147483647 h 2213"/>
                  <a:gd name="T2" fmla="*/ 2147483647 w 32"/>
                  <a:gd name="T3" fmla="*/ 2147483647 h 2213"/>
                  <a:gd name="T4" fmla="*/ 2147483647 w 32"/>
                  <a:gd name="T5" fmla="*/ 2147483647 h 2213"/>
                  <a:gd name="T6" fmla="*/ 0 w 32"/>
                  <a:gd name="T7" fmla="*/ 2147483647 h 2213"/>
                  <a:gd name="T8" fmla="*/ 0 w 32"/>
                  <a:gd name="T9" fmla="*/ 2147483647 h 2213"/>
                  <a:gd name="T10" fmla="*/ 0 w 32"/>
                  <a:gd name="T11" fmla="*/ 2147483647 h 2213"/>
                  <a:gd name="T12" fmla="*/ 2147483647 w 32"/>
                  <a:gd name="T13" fmla="*/ 2147483647 h 2213"/>
                  <a:gd name="T14" fmla="*/ 2147483647 w 32"/>
                  <a:gd name="T15" fmla="*/ 2147483647 h 2213"/>
                  <a:gd name="T16" fmla="*/ 0 w 32"/>
                  <a:gd name="T17" fmla="*/ 2147483647 h 2213"/>
                  <a:gd name="T18" fmla="*/ 0 w 32"/>
                  <a:gd name="T19" fmla="*/ 2147483647 h 2213"/>
                  <a:gd name="T20" fmla="*/ 0 w 32"/>
                  <a:gd name="T21" fmla="*/ 2147483647 h 2213"/>
                  <a:gd name="T22" fmla="*/ 2147483647 w 32"/>
                  <a:gd name="T23" fmla="*/ 2147483647 h 2213"/>
                  <a:gd name="T24" fmla="*/ 2147483647 w 32"/>
                  <a:gd name="T25" fmla="*/ 2147483647 h 2213"/>
                  <a:gd name="T26" fmla="*/ 0 w 32"/>
                  <a:gd name="T27" fmla="*/ 2147483647 h 2213"/>
                  <a:gd name="T28" fmla="*/ 0 w 32"/>
                  <a:gd name="T29" fmla="*/ 2147483647 h 2213"/>
                  <a:gd name="T30" fmla="*/ 0 w 32"/>
                  <a:gd name="T31" fmla="*/ 2147483647 h 2213"/>
                  <a:gd name="T32" fmla="*/ 2147483647 w 32"/>
                  <a:gd name="T33" fmla="*/ 2147483647 h 2213"/>
                  <a:gd name="T34" fmla="*/ 2147483647 w 32"/>
                  <a:gd name="T35" fmla="*/ 2147483647 h 2213"/>
                  <a:gd name="T36" fmla="*/ 0 w 32"/>
                  <a:gd name="T37" fmla="*/ 2147483647 h 2213"/>
                  <a:gd name="T38" fmla="*/ 0 w 32"/>
                  <a:gd name="T39" fmla="*/ 2147483647 h 2213"/>
                  <a:gd name="T40" fmla="*/ 0 w 32"/>
                  <a:gd name="T41" fmla="*/ 2147483647 h 2213"/>
                  <a:gd name="T42" fmla="*/ 2147483647 w 32"/>
                  <a:gd name="T43" fmla="*/ 2147483647 h 2213"/>
                  <a:gd name="T44" fmla="*/ 2147483647 w 32"/>
                  <a:gd name="T45" fmla="*/ 2147483647 h 2213"/>
                  <a:gd name="T46" fmla="*/ 0 w 32"/>
                  <a:gd name="T47" fmla="*/ 2147483647 h 2213"/>
                  <a:gd name="T48" fmla="*/ 0 w 32"/>
                  <a:gd name="T49" fmla="*/ 2147483647 h 2213"/>
                  <a:gd name="T50" fmla="*/ 0 w 32"/>
                  <a:gd name="T51" fmla="*/ 0 h 2213"/>
                  <a:gd name="T52" fmla="*/ 2147483647 w 32"/>
                  <a:gd name="T53" fmla="*/ 0 h 2213"/>
                  <a:gd name="T54" fmla="*/ 2147483647 w 32"/>
                  <a:gd name="T55" fmla="*/ 2147483647 h 2213"/>
                  <a:gd name="T56" fmla="*/ 0 w 32"/>
                  <a:gd name="T57" fmla="*/ 2147483647 h 2213"/>
                  <a:gd name="T58" fmla="*/ 0 w 32"/>
                  <a:gd name="T59" fmla="*/ 0 h 2213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w 32"/>
                  <a:gd name="T91" fmla="*/ 0 h 2213"/>
                  <a:gd name="T92" fmla="*/ 32 w 32"/>
                  <a:gd name="T93" fmla="*/ 2213 h 2213"/>
                </a:gdLst>
                <a:ahLst/>
                <a:cxnLst>
                  <a:cxn ang="T60">
                    <a:pos x="T0" y="T1"/>
                  </a:cxn>
                  <a:cxn ang="T61">
                    <a:pos x="T2" y="T3"/>
                  </a:cxn>
                  <a:cxn ang="T62">
                    <a:pos x="T4" y="T5"/>
                  </a:cxn>
                  <a:cxn ang="T63">
                    <a:pos x="T6" y="T7"/>
                  </a:cxn>
                  <a:cxn ang="T64">
                    <a:pos x="T8" y="T9"/>
                  </a:cxn>
                  <a:cxn ang="T65">
                    <a:pos x="T10" y="T11"/>
                  </a:cxn>
                  <a:cxn ang="T66">
                    <a:pos x="T12" y="T13"/>
                  </a:cxn>
                  <a:cxn ang="T67">
                    <a:pos x="T14" y="T15"/>
                  </a:cxn>
                  <a:cxn ang="T68">
                    <a:pos x="T16" y="T17"/>
                  </a:cxn>
                  <a:cxn ang="T69">
                    <a:pos x="T18" y="T19"/>
                  </a:cxn>
                  <a:cxn ang="T70">
                    <a:pos x="T20" y="T21"/>
                  </a:cxn>
                  <a:cxn ang="T71">
                    <a:pos x="T22" y="T23"/>
                  </a:cxn>
                  <a:cxn ang="T72">
                    <a:pos x="T24" y="T25"/>
                  </a:cxn>
                  <a:cxn ang="T73">
                    <a:pos x="T26" y="T27"/>
                  </a:cxn>
                  <a:cxn ang="T74">
                    <a:pos x="T28" y="T29"/>
                  </a:cxn>
                  <a:cxn ang="T75">
                    <a:pos x="T30" y="T31"/>
                  </a:cxn>
                  <a:cxn ang="T76">
                    <a:pos x="T32" y="T33"/>
                  </a:cxn>
                  <a:cxn ang="T77">
                    <a:pos x="T34" y="T35"/>
                  </a:cxn>
                  <a:cxn ang="T78">
                    <a:pos x="T36" y="T37"/>
                  </a:cxn>
                  <a:cxn ang="T79">
                    <a:pos x="T38" y="T39"/>
                  </a:cxn>
                  <a:cxn ang="T80">
                    <a:pos x="T40" y="T41"/>
                  </a:cxn>
                  <a:cxn ang="T81">
                    <a:pos x="T42" y="T43"/>
                  </a:cxn>
                  <a:cxn ang="T82">
                    <a:pos x="T44" y="T45"/>
                  </a:cxn>
                  <a:cxn ang="T83">
                    <a:pos x="T46" y="T47"/>
                  </a:cxn>
                  <a:cxn ang="T84">
                    <a:pos x="T48" y="T49"/>
                  </a:cxn>
                  <a:cxn ang="T85">
                    <a:pos x="T50" y="T51"/>
                  </a:cxn>
                  <a:cxn ang="T86">
                    <a:pos x="T52" y="T53"/>
                  </a:cxn>
                  <a:cxn ang="T87">
                    <a:pos x="T54" y="T55"/>
                  </a:cxn>
                  <a:cxn ang="T88">
                    <a:pos x="T56" y="T57"/>
                  </a:cxn>
                  <a:cxn ang="T89">
                    <a:pos x="T58" y="T59"/>
                  </a:cxn>
                </a:cxnLst>
                <a:rect l="T90" t="T91" r="T92" b="T93"/>
                <a:pathLst>
                  <a:path w="32" h="2213">
                    <a:moveTo>
                      <a:pt x="0" y="2209"/>
                    </a:moveTo>
                    <a:lnTo>
                      <a:pt x="32" y="2209"/>
                    </a:lnTo>
                    <a:lnTo>
                      <a:pt x="32" y="2213"/>
                    </a:lnTo>
                    <a:lnTo>
                      <a:pt x="0" y="2213"/>
                    </a:lnTo>
                    <a:lnTo>
                      <a:pt x="0" y="2209"/>
                    </a:lnTo>
                    <a:close/>
                    <a:moveTo>
                      <a:pt x="0" y="1768"/>
                    </a:moveTo>
                    <a:lnTo>
                      <a:pt x="32" y="1768"/>
                    </a:lnTo>
                    <a:lnTo>
                      <a:pt x="32" y="1772"/>
                    </a:lnTo>
                    <a:lnTo>
                      <a:pt x="0" y="1772"/>
                    </a:lnTo>
                    <a:lnTo>
                      <a:pt x="0" y="1768"/>
                    </a:lnTo>
                    <a:close/>
                    <a:moveTo>
                      <a:pt x="0" y="1327"/>
                    </a:moveTo>
                    <a:lnTo>
                      <a:pt x="32" y="1327"/>
                    </a:lnTo>
                    <a:lnTo>
                      <a:pt x="32" y="1332"/>
                    </a:lnTo>
                    <a:lnTo>
                      <a:pt x="0" y="1332"/>
                    </a:lnTo>
                    <a:lnTo>
                      <a:pt x="0" y="1327"/>
                    </a:lnTo>
                    <a:close/>
                    <a:moveTo>
                      <a:pt x="0" y="882"/>
                    </a:moveTo>
                    <a:lnTo>
                      <a:pt x="32" y="882"/>
                    </a:lnTo>
                    <a:lnTo>
                      <a:pt x="32" y="886"/>
                    </a:lnTo>
                    <a:lnTo>
                      <a:pt x="0" y="886"/>
                    </a:lnTo>
                    <a:lnTo>
                      <a:pt x="0" y="882"/>
                    </a:lnTo>
                    <a:close/>
                    <a:moveTo>
                      <a:pt x="0" y="441"/>
                    </a:moveTo>
                    <a:lnTo>
                      <a:pt x="32" y="441"/>
                    </a:lnTo>
                    <a:lnTo>
                      <a:pt x="32" y="445"/>
                    </a:lnTo>
                    <a:lnTo>
                      <a:pt x="0" y="445"/>
                    </a:lnTo>
                    <a:lnTo>
                      <a:pt x="0" y="441"/>
                    </a:lnTo>
                    <a:close/>
                    <a:moveTo>
                      <a:pt x="0" y="0"/>
                    </a:moveTo>
                    <a:lnTo>
                      <a:pt x="32" y="0"/>
                    </a:lnTo>
                    <a:lnTo>
                      <a:pt x="32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5">
                <a:solidFill>
                  <a:srgbClr val="868686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99" name="Rectangle 13"/>
              <p:cNvSpPr>
                <a:spLocks noChangeArrowheads="1"/>
              </p:cNvSpPr>
              <p:nvPr/>
            </p:nvSpPr>
            <p:spPr bwMode="auto">
              <a:xfrm>
                <a:off x="1981200" y="3659188"/>
                <a:ext cx="6708775" cy="4762"/>
              </a:xfrm>
              <a:prstGeom prst="rect">
                <a:avLst/>
              </a:prstGeom>
              <a:solidFill>
                <a:srgbClr val="868686"/>
              </a:solidFill>
              <a:ln w="5">
                <a:solidFill>
                  <a:srgbClr val="868686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00" name="Freeform 14"/>
              <p:cNvSpPr>
                <a:spLocks noEditPoints="1"/>
              </p:cNvSpPr>
              <p:nvPr/>
            </p:nvSpPr>
            <p:spPr bwMode="auto">
              <a:xfrm>
                <a:off x="1978025" y="3660775"/>
                <a:ext cx="6716713" cy="33338"/>
              </a:xfrm>
              <a:custGeom>
                <a:avLst/>
                <a:gdLst>
                  <a:gd name="T0" fmla="*/ 2147483647 w 4634"/>
                  <a:gd name="T1" fmla="*/ 0 h 28"/>
                  <a:gd name="T2" fmla="*/ 2147483647 w 4634"/>
                  <a:gd name="T3" fmla="*/ 2147483647 h 28"/>
                  <a:gd name="T4" fmla="*/ 0 w 4634"/>
                  <a:gd name="T5" fmla="*/ 2147483647 h 28"/>
                  <a:gd name="T6" fmla="*/ 0 w 4634"/>
                  <a:gd name="T7" fmla="*/ 0 h 28"/>
                  <a:gd name="T8" fmla="*/ 2147483647 w 4634"/>
                  <a:gd name="T9" fmla="*/ 0 h 28"/>
                  <a:gd name="T10" fmla="*/ 2147483647 w 4634"/>
                  <a:gd name="T11" fmla="*/ 0 h 28"/>
                  <a:gd name="T12" fmla="*/ 2147483647 w 4634"/>
                  <a:gd name="T13" fmla="*/ 2147483647 h 28"/>
                  <a:gd name="T14" fmla="*/ 2147483647 w 4634"/>
                  <a:gd name="T15" fmla="*/ 2147483647 h 28"/>
                  <a:gd name="T16" fmla="*/ 2147483647 w 4634"/>
                  <a:gd name="T17" fmla="*/ 0 h 28"/>
                  <a:gd name="T18" fmla="*/ 2147483647 w 4634"/>
                  <a:gd name="T19" fmla="*/ 0 h 28"/>
                  <a:gd name="T20" fmla="*/ 2147483647 w 4634"/>
                  <a:gd name="T21" fmla="*/ 0 h 28"/>
                  <a:gd name="T22" fmla="*/ 2147483647 w 4634"/>
                  <a:gd name="T23" fmla="*/ 2147483647 h 28"/>
                  <a:gd name="T24" fmla="*/ 2147483647 w 4634"/>
                  <a:gd name="T25" fmla="*/ 2147483647 h 28"/>
                  <a:gd name="T26" fmla="*/ 2147483647 w 4634"/>
                  <a:gd name="T27" fmla="*/ 0 h 28"/>
                  <a:gd name="T28" fmla="*/ 2147483647 w 4634"/>
                  <a:gd name="T29" fmla="*/ 0 h 28"/>
                  <a:gd name="T30" fmla="*/ 2147483647 w 4634"/>
                  <a:gd name="T31" fmla="*/ 0 h 28"/>
                  <a:gd name="T32" fmla="*/ 2147483647 w 4634"/>
                  <a:gd name="T33" fmla="*/ 2147483647 h 28"/>
                  <a:gd name="T34" fmla="*/ 2147483647 w 4634"/>
                  <a:gd name="T35" fmla="*/ 2147483647 h 28"/>
                  <a:gd name="T36" fmla="*/ 2147483647 w 4634"/>
                  <a:gd name="T37" fmla="*/ 0 h 28"/>
                  <a:gd name="T38" fmla="*/ 2147483647 w 4634"/>
                  <a:gd name="T39" fmla="*/ 0 h 28"/>
                  <a:gd name="T40" fmla="*/ 2147483647 w 4634"/>
                  <a:gd name="T41" fmla="*/ 0 h 28"/>
                  <a:gd name="T42" fmla="*/ 2147483647 w 4634"/>
                  <a:gd name="T43" fmla="*/ 2147483647 h 28"/>
                  <a:gd name="T44" fmla="*/ 2147483647 w 4634"/>
                  <a:gd name="T45" fmla="*/ 2147483647 h 28"/>
                  <a:gd name="T46" fmla="*/ 2147483647 w 4634"/>
                  <a:gd name="T47" fmla="*/ 0 h 28"/>
                  <a:gd name="T48" fmla="*/ 2147483647 w 4634"/>
                  <a:gd name="T49" fmla="*/ 0 h 28"/>
                  <a:gd name="T50" fmla="*/ 2147483647 w 4634"/>
                  <a:gd name="T51" fmla="*/ 0 h 28"/>
                  <a:gd name="T52" fmla="*/ 2147483647 w 4634"/>
                  <a:gd name="T53" fmla="*/ 2147483647 h 28"/>
                  <a:gd name="T54" fmla="*/ 2147483647 w 4634"/>
                  <a:gd name="T55" fmla="*/ 2147483647 h 28"/>
                  <a:gd name="T56" fmla="*/ 2147483647 w 4634"/>
                  <a:gd name="T57" fmla="*/ 0 h 28"/>
                  <a:gd name="T58" fmla="*/ 2147483647 w 4634"/>
                  <a:gd name="T59" fmla="*/ 0 h 28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w 4634"/>
                  <a:gd name="T91" fmla="*/ 0 h 28"/>
                  <a:gd name="T92" fmla="*/ 4634 w 4634"/>
                  <a:gd name="T93" fmla="*/ 28 h 28"/>
                </a:gdLst>
                <a:ahLst/>
                <a:cxnLst>
                  <a:cxn ang="T60">
                    <a:pos x="T0" y="T1"/>
                  </a:cxn>
                  <a:cxn ang="T61">
                    <a:pos x="T2" y="T3"/>
                  </a:cxn>
                  <a:cxn ang="T62">
                    <a:pos x="T4" y="T5"/>
                  </a:cxn>
                  <a:cxn ang="T63">
                    <a:pos x="T6" y="T7"/>
                  </a:cxn>
                  <a:cxn ang="T64">
                    <a:pos x="T8" y="T9"/>
                  </a:cxn>
                  <a:cxn ang="T65">
                    <a:pos x="T10" y="T11"/>
                  </a:cxn>
                  <a:cxn ang="T66">
                    <a:pos x="T12" y="T13"/>
                  </a:cxn>
                  <a:cxn ang="T67">
                    <a:pos x="T14" y="T15"/>
                  </a:cxn>
                  <a:cxn ang="T68">
                    <a:pos x="T16" y="T17"/>
                  </a:cxn>
                  <a:cxn ang="T69">
                    <a:pos x="T18" y="T19"/>
                  </a:cxn>
                  <a:cxn ang="T70">
                    <a:pos x="T20" y="T21"/>
                  </a:cxn>
                  <a:cxn ang="T71">
                    <a:pos x="T22" y="T23"/>
                  </a:cxn>
                  <a:cxn ang="T72">
                    <a:pos x="T24" y="T25"/>
                  </a:cxn>
                  <a:cxn ang="T73">
                    <a:pos x="T26" y="T27"/>
                  </a:cxn>
                  <a:cxn ang="T74">
                    <a:pos x="T28" y="T29"/>
                  </a:cxn>
                  <a:cxn ang="T75">
                    <a:pos x="T30" y="T31"/>
                  </a:cxn>
                  <a:cxn ang="T76">
                    <a:pos x="T32" y="T33"/>
                  </a:cxn>
                  <a:cxn ang="T77">
                    <a:pos x="T34" y="T35"/>
                  </a:cxn>
                  <a:cxn ang="T78">
                    <a:pos x="T36" y="T37"/>
                  </a:cxn>
                  <a:cxn ang="T79">
                    <a:pos x="T38" y="T39"/>
                  </a:cxn>
                  <a:cxn ang="T80">
                    <a:pos x="T40" y="T41"/>
                  </a:cxn>
                  <a:cxn ang="T81">
                    <a:pos x="T42" y="T43"/>
                  </a:cxn>
                  <a:cxn ang="T82">
                    <a:pos x="T44" y="T45"/>
                  </a:cxn>
                  <a:cxn ang="T83">
                    <a:pos x="T46" y="T47"/>
                  </a:cxn>
                  <a:cxn ang="T84">
                    <a:pos x="T48" y="T49"/>
                  </a:cxn>
                  <a:cxn ang="T85">
                    <a:pos x="T50" y="T51"/>
                  </a:cxn>
                  <a:cxn ang="T86">
                    <a:pos x="T52" y="T53"/>
                  </a:cxn>
                  <a:cxn ang="T87">
                    <a:pos x="T54" y="T55"/>
                  </a:cxn>
                  <a:cxn ang="T88">
                    <a:pos x="T56" y="T57"/>
                  </a:cxn>
                  <a:cxn ang="T89">
                    <a:pos x="T58" y="T59"/>
                  </a:cxn>
                </a:cxnLst>
                <a:rect l="T90" t="T91" r="T92" b="T93"/>
                <a:pathLst>
                  <a:path w="4634" h="28">
                    <a:moveTo>
                      <a:pt x="4" y="0"/>
                    </a:moveTo>
                    <a:lnTo>
                      <a:pt x="4" y="28"/>
                    </a:lnTo>
                    <a:lnTo>
                      <a:pt x="0" y="28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932" y="0"/>
                    </a:moveTo>
                    <a:lnTo>
                      <a:pt x="932" y="28"/>
                    </a:lnTo>
                    <a:lnTo>
                      <a:pt x="927" y="28"/>
                    </a:lnTo>
                    <a:lnTo>
                      <a:pt x="927" y="0"/>
                    </a:lnTo>
                    <a:lnTo>
                      <a:pt x="932" y="0"/>
                    </a:lnTo>
                    <a:close/>
                    <a:moveTo>
                      <a:pt x="1855" y="0"/>
                    </a:moveTo>
                    <a:lnTo>
                      <a:pt x="1855" y="28"/>
                    </a:lnTo>
                    <a:lnTo>
                      <a:pt x="1851" y="28"/>
                    </a:lnTo>
                    <a:lnTo>
                      <a:pt x="1851" y="0"/>
                    </a:lnTo>
                    <a:lnTo>
                      <a:pt x="1855" y="0"/>
                    </a:lnTo>
                    <a:close/>
                    <a:moveTo>
                      <a:pt x="2783" y="0"/>
                    </a:moveTo>
                    <a:lnTo>
                      <a:pt x="2783" y="28"/>
                    </a:lnTo>
                    <a:lnTo>
                      <a:pt x="2778" y="28"/>
                    </a:lnTo>
                    <a:lnTo>
                      <a:pt x="2778" y="0"/>
                    </a:lnTo>
                    <a:lnTo>
                      <a:pt x="2783" y="0"/>
                    </a:lnTo>
                    <a:close/>
                    <a:moveTo>
                      <a:pt x="3706" y="0"/>
                    </a:moveTo>
                    <a:lnTo>
                      <a:pt x="3706" y="28"/>
                    </a:lnTo>
                    <a:lnTo>
                      <a:pt x="3701" y="28"/>
                    </a:lnTo>
                    <a:lnTo>
                      <a:pt x="3701" y="0"/>
                    </a:lnTo>
                    <a:lnTo>
                      <a:pt x="3706" y="0"/>
                    </a:lnTo>
                    <a:close/>
                    <a:moveTo>
                      <a:pt x="4634" y="0"/>
                    </a:moveTo>
                    <a:lnTo>
                      <a:pt x="4634" y="28"/>
                    </a:lnTo>
                    <a:lnTo>
                      <a:pt x="4629" y="28"/>
                    </a:lnTo>
                    <a:lnTo>
                      <a:pt x="4629" y="0"/>
                    </a:lnTo>
                    <a:lnTo>
                      <a:pt x="4634" y="0"/>
                    </a:lnTo>
                    <a:close/>
                  </a:path>
                </a:pathLst>
              </a:custGeom>
              <a:solidFill>
                <a:srgbClr val="868686"/>
              </a:solidFill>
              <a:ln w="5">
                <a:solidFill>
                  <a:srgbClr val="868686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01" name="Rectangle 15"/>
              <p:cNvSpPr>
                <a:spLocks noChangeArrowheads="1"/>
              </p:cNvSpPr>
              <p:nvPr/>
            </p:nvSpPr>
            <p:spPr bwMode="auto">
              <a:xfrm>
                <a:off x="1779588" y="3600450"/>
                <a:ext cx="90487" cy="193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0</a:t>
                </a:r>
                <a:endParaRPr lang="en-US" sz="1400"/>
              </a:p>
            </p:txBody>
          </p:sp>
          <p:sp>
            <p:nvSpPr>
              <p:cNvPr id="28702" name="Rectangle 16"/>
              <p:cNvSpPr>
                <a:spLocks noChangeArrowheads="1"/>
              </p:cNvSpPr>
              <p:nvPr/>
            </p:nvSpPr>
            <p:spPr bwMode="auto">
              <a:xfrm>
                <a:off x="1698625" y="3076575"/>
                <a:ext cx="182563" cy="195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10</a:t>
                </a:r>
                <a:endParaRPr lang="en-US" sz="1400"/>
              </a:p>
            </p:txBody>
          </p:sp>
          <p:sp>
            <p:nvSpPr>
              <p:cNvPr id="28703" name="Rectangle 17"/>
              <p:cNvSpPr>
                <a:spLocks noChangeArrowheads="1"/>
              </p:cNvSpPr>
              <p:nvPr/>
            </p:nvSpPr>
            <p:spPr bwMode="auto">
              <a:xfrm>
                <a:off x="1698625" y="2552700"/>
                <a:ext cx="182563" cy="195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20</a:t>
                </a:r>
                <a:endParaRPr lang="en-US" sz="1400"/>
              </a:p>
            </p:txBody>
          </p:sp>
          <p:sp>
            <p:nvSpPr>
              <p:cNvPr id="28704" name="Rectangle 18"/>
              <p:cNvSpPr>
                <a:spLocks noChangeArrowheads="1"/>
              </p:cNvSpPr>
              <p:nvPr/>
            </p:nvSpPr>
            <p:spPr bwMode="auto">
              <a:xfrm>
                <a:off x="1698625" y="2028825"/>
                <a:ext cx="182563" cy="195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30</a:t>
                </a:r>
                <a:endParaRPr lang="en-US" sz="1400"/>
              </a:p>
            </p:txBody>
          </p:sp>
          <p:sp>
            <p:nvSpPr>
              <p:cNvPr id="28705" name="Rectangle 19"/>
              <p:cNvSpPr>
                <a:spLocks noChangeArrowheads="1"/>
              </p:cNvSpPr>
              <p:nvPr/>
            </p:nvSpPr>
            <p:spPr bwMode="auto">
              <a:xfrm>
                <a:off x="1698625" y="1506538"/>
                <a:ext cx="182563" cy="193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40</a:t>
                </a:r>
                <a:endParaRPr lang="en-US" sz="1400"/>
              </a:p>
            </p:txBody>
          </p:sp>
          <p:sp>
            <p:nvSpPr>
              <p:cNvPr id="28706" name="Rectangle 20"/>
              <p:cNvSpPr>
                <a:spLocks noChangeArrowheads="1"/>
              </p:cNvSpPr>
              <p:nvPr/>
            </p:nvSpPr>
            <p:spPr bwMode="auto">
              <a:xfrm>
                <a:off x="1698625" y="982663"/>
                <a:ext cx="182563" cy="1952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50</a:t>
                </a:r>
                <a:endParaRPr lang="en-US" sz="1400"/>
              </a:p>
            </p:txBody>
          </p:sp>
          <p:sp>
            <p:nvSpPr>
              <p:cNvPr id="28707" name="Rectangle 21"/>
              <p:cNvSpPr>
                <a:spLocks noChangeArrowheads="1"/>
              </p:cNvSpPr>
              <p:nvPr/>
            </p:nvSpPr>
            <p:spPr bwMode="auto">
              <a:xfrm>
                <a:off x="2347913" y="3767138"/>
                <a:ext cx="700087" cy="1952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CW*1701</a:t>
                </a:r>
                <a:endParaRPr lang="en-US" sz="1400"/>
              </a:p>
            </p:txBody>
          </p:sp>
          <p:sp>
            <p:nvSpPr>
              <p:cNvPr id="28708" name="Rectangle 22"/>
              <p:cNvSpPr>
                <a:spLocks noChangeArrowheads="1"/>
              </p:cNvSpPr>
              <p:nvPr/>
            </p:nvSpPr>
            <p:spPr bwMode="auto">
              <a:xfrm>
                <a:off x="3689350" y="3767138"/>
                <a:ext cx="701675" cy="1952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CW*0602</a:t>
                </a:r>
                <a:endParaRPr lang="en-US" sz="1400"/>
              </a:p>
            </p:txBody>
          </p:sp>
          <p:sp>
            <p:nvSpPr>
              <p:cNvPr id="28709" name="Rectangle 23"/>
              <p:cNvSpPr>
                <a:spLocks noChangeArrowheads="1"/>
              </p:cNvSpPr>
              <p:nvPr/>
            </p:nvSpPr>
            <p:spPr bwMode="auto">
              <a:xfrm>
                <a:off x="5032375" y="3767138"/>
                <a:ext cx="700088" cy="1952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CW*0403</a:t>
                </a:r>
                <a:endParaRPr lang="en-US" sz="1400"/>
              </a:p>
            </p:txBody>
          </p:sp>
          <p:sp>
            <p:nvSpPr>
              <p:cNvPr id="28710" name="Rectangle 24"/>
              <p:cNvSpPr>
                <a:spLocks noChangeArrowheads="1"/>
              </p:cNvSpPr>
              <p:nvPr/>
            </p:nvSpPr>
            <p:spPr bwMode="auto">
              <a:xfrm>
                <a:off x="6373813" y="3767138"/>
                <a:ext cx="701675" cy="1952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CW*1802</a:t>
                </a:r>
                <a:endParaRPr lang="en-US" sz="1400"/>
              </a:p>
            </p:txBody>
          </p:sp>
          <p:sp>
            <p:nvSpPr>
              <p:cNvPr id="28711" name="Rectangle 25"/>
              <p:cNvSpPr>
                <a:spLocks noChangeArrowheads="1"/>
              </p:cNvSpPr>
              <p:nvPr/>
            </p:nvSpPr>
            <p:spPr bwMode="auto">
              <a:xfrm>
                <a:off x="7716838" y="3767138"/>
                <a:ext cx="701675" cy="1952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CW*0702</a:t>
                </a:r>
                <a:endParaRPr lang="en-US" sz="1400"/>
              </a:p>
            </p:txBody>
          </p:sp>
          <p:sp>
            <p:nvSpPr>
              <p:cNvPr id="28712" name="Rectangle 26"/>
              <p:cNvSpPr>
                <a:spLocks noChangeArrowheads="1"/>
              </p:cNvSpPr>
              <p:nvPr/>
            </p:nvSpPr>
            <p:spPr bwMode="auto">
              <a:xfrm rot="16200000">
                <a:off x="1079871" y="2296022"/>
                <a:ext cx="825499" cy="1958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200" dirty="0" smtClean="0">
                    <a:solidFill>
                      <a:srgbClr val="000000"/>
                    </a:solidFill>
                  </a:rPr>
                  <a:t>(Hundreds)</a:t>
                </a:r>
                <a:endParaRPr lang="en-US" sz="1200" dirty="0"/>
              </a:p>
            </p:txBody>
          </p:sp>
          <p:sp>
            <p:nvSpPr>
              <p:cNvPr id="28713" name="Rectangle 32"/>
              <p:cNvSpPr>
                <a:spLocks noChangeArrowheads="1"/>
              </p:cNvSpPr>
              <p:nvPr/>
            </p:nvSpPr>
            <p:spPr bwMode="auto">
              <a:xfrm>
                <a:off x="3598863" y="850900"/>
                <a:ext cx="1063625" cy="195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Intact antigens</a:t>
                </a:r>
                <a:endParaRPr lang="en-US" sz="1400"/>
              </a:p>
            </p:txBody>
          </p:sp>
          <p:sp>
            <p:nvSpPr>
              <p:cNvPr id="28714" name="Rectangle 33"/>
              <p:cNvSpPr>
                <a:spLocks noChangeArrowheads="1"/>
              </p:cNvSpPr>
              <p:nvPr/>
            </p:nvSpPr>
            <p:spPr bwMode="auto">
              <a:xfrm>
                <a:off x="4922838" y="876300"/>
                <a:ext cx="173037" cy="146050"/>
              </a:xfrm>
              <a:prstGeom prst="rect">
                <a:avLst/>
              </a:prstGeom>
              <a:solidFill>
                <a:srgbClr val="00B05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15" name="Rectangle 34"/>
              <p:cNvSpPr>
                <a:spLocks noChangeArrowheads="1"/>
              </p:cNvSpPr>
              <p:nvPr/>
            </p:nvSpPr>
            <p:spPr bwMode="auto">
              <a:xfrm>
                <a:off x="5165725" y="850900"/>
                <a:ext cx="1508125" cy="195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400">
                    <a:solidFill>
                      <a:srgbClr val="000000"/>
                    </a:solidFill>
                  </a:rPr>
                  <a:t>Dissociated antigens</a:t>
                </a:r>
                <a:endParaRPr lang="en-US" sz="1400"/>
              </a:p>
            </p:txBody>
          </p:sp>
          <p:sp>
            <p:nvSpPr>
              <p:cNvPr id="28716" name="Rectangle 31"/>
              <p:cNvSpPr>
                <a:spLocks noChangeArrowheads="1"/>
              </p:cNvSpPr>
              <p:nvPr/>
            </p:nvSpPr>
            <p:spPr bwMode="auto">
              <a:xfrm>
                <a:off x="3352800" y="876300"/>
                <a:ext cx="174625" cy="146050"/>
              </a:xfrm>
              <a:prstGeom prst="rect">
                <a:avLst/>
              </a:prstGeom>
              <a:solidFill>
                <a:srgbClr val="C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1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1268413" y="4495800"/>
                <a:ext cx="2824162" cy="17970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18" name="Rectangle 5"/>
              <p:cNvSpPr>
                <a:spLocks noChangeArrowheads="1"/>
              </p:cNvSpPr>
              <p:nvPr/>
            </p:nvSpPr>
            <p:spPr bwMode="auto">
              <a:xfrm>
                <a:off x="2628900" y="5178425"/>
                <a:ext cx="1457325" cy="885825"/>
              </a:xfrm>
              <a:prstGeom prst="rect">
                <a:avLst/>
              </a:prstGeom>
              <a:solidFill>
                <a:srgbClr val="A5A5A5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19" name="Rectangle 6"/>
              <p:cNvSpPr>
                <a:spLocks noChangeArrowheads="1"/>
              </p:cNvSpPr>
              <p:nvPr/>
            </p:nvSpPr>
            <p:spPr bwMode="auto">
              <a:xfrm>
                <a:off x="2894013" y="4740275"/>
                <a:ext cx="195262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73</a:t>
                </a:r>
                <a:endParaRPr lang="en-US"/>
              </a:p>
            </p:txBody>
          </p:sp>
          <p:sp>
            <p:nvSpPr>
              <p:cNvPr id="28720" name="Rectangle 7"/>
              <p:cNvSpPr>
                <a:spLocks noChangeArrowheads="1"/>
              </p:cNvSpPr>
              <p:nvPr/>
            </p:nvSpPr>
            <p:spPr bwMode="auto">
              <a:xfrm>
                <a:off x="3621088" y="4740275"/>
                <a:ext cx="196850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77</a:t>
                </a:r>
                <a:endParaRPr lang="en-US"/>
              </a:p>
            </p:txBody>
          </p:sp>
          <p:sp>
            <p:nvSpPr>
              <p:cNvPr id="28721" name="Rectangle 8"/>
              <p:cNvSpPr>
                <a:spLocks noChangeArrowheads="1"/>
              </p:cNvSpPr>
              <p:nvPr/>
            </p:nvSpPr>
            <p:spPr bwMode="auto">
              <a:xfrm>
                <a:off x="1308100" y="4957763"/>
                <a:ext cx="911225" cy="219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Cw*010201</a:t>
                </a:r>
                <a:endParaRPr lang="en-US"/>
              </a:p>
            </p:txBody>
          </p:sp>
          <p:sp>
            <p:nvSpPr>
              <p:cNvPr id="28722" name="Rectangle 9"/>
              <p:cNvSpPr>
                <a:spLocks noChangeArrowheads="1"/>
              </p:cNvSpPr>
              <p:nvPr/>
            </p:nvSpPr>
            <p:spPr bwMode="auto">
              <a:xfrm>
                <a:off x="2936875" y="4957763"/>
                <a:ext cx="107950" cy="219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T</a:t>
                </a:r>
                <a:endParaRPr lang="en-US"/>
              </a:p>
            </p:txBody>
          </p:sp>
          <p:sp>
            <p:nvSpPr>
              <p:cNvPr id="28723" name="Rectangle 10"/>
              <p:cNvSpPr>
                <a:spLocks noChangeArrowheads="1"/>
              </p:cNvSpPr>
              <p:nvPr/>
            </p:nvSpPr>
            <p:spPr bwMode="auto">
              <a:xfrm>
                <a:off x="3660775" y="4957763"/>
                <a:ext cx="117475" cy="219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S</a:t>
                </a:r>
                <a:endParaRPr lang="en-US"/>
              </a:p>
            </p:txBody>
          </p:sp>
          <p:sp>
            <p:nvSpPr>
              <p:cNvPr id="28724" name="Rectangle 11"/>
              <p:cNvSpPr>
                <a:spLocks noChangeArrowheads="1"/>
              </p:cNvSpPr>
              <p:nvPr/>
            </p:nvSpPr>
            <p:spPr bwMode="auto">
              <a:xfrm>
                <a:off x="1308100" y="5192713"/>
                <a:ext cx="715963" cy="219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Cw*0403</a:t>
                </a:r>
                <a:endParaRPr lang="en-US"/>
              </a:p>
            </p:txBody>
          </p:sp>
          <p:sp>
            <p:nvSpPr>
              <p:cNvPr id="28725" name="Rectangle 12"/>
              <p:cNvSpPr>
                <a:spLocks noChangeArrowheads="1"/>
              </p:cNvSpPr>
              <p:nvPr/>
            </p:nvSpPr>
            <p:spPr bwMode="auto">
              <a:xfrm>
                <a:off x="2932113" y="5192713"/>
                <a:ext cx="115887" cy="219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A</a:t>
                </a:r>
                <a:endParaRPr lang="en-US"/>
              </a:p>
            </p:txBody>
          </p:sp>
          <p:sp>
            <p:nvSpPr>
              <p:cNvPr id="28726" name="Rectangle 13"/>
              <p:cNvSpPr>
                <a:spLocks noChangeArrowheads="1"/>
              </p:cNvSpPr>
              <p:nvPr/>
            </p:nvSpPr>
            <p:spPr bwMode="auto">
              <a:xfrm>
                <a:off x="3656013" y="5192713"/>
                <a:ext cx="127000" cy="219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N</a:t>
                </a:r>
                <a:endParaRPr lang="en-US"/>
              </a:p>
            </p:txBody>
          </p:sp>
          <p:sp>
            <p:nvSpPr>
              <p:cNvPr id="28727" name="Rectangle 14"/>
              <p:cNvSpPr>
                <a:spLocks noChangeArrowheads="1"/>
              </p:cNvSpPr>
              <p:nvPr/>
            </p:nvSpPr>
            <p:spPr bwMode="auto">
              <a:xfrm>
                <a:off x="1308100" y="5414963"/>
                <a:ext cx="715963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Cw*0602</a:t>
                </a:r>
                <a:endParaRPr lang="en-US"/>
              </a:p>
            </p:txBody>
          </p:sp>
          <p:sp>
            <p:nvSpPr>
              <p:cNvPr id="28728" name="Rectangle 15"/>
              <p:cNvSpPr>
                <a:spLocks noChangeArrowheads="1"/>
              </p:cNvSpPr>
              <p:nvPr/>
            </p:nvSpPr>
            <p:spPr bwMode="auto">
              <a:xfrm>
                <a:off x="2932113" y="5414963"/>
                <a:ext cx="115887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A</a:t>
                </a:r>
                <a:endParaRPr lang="en-US"/>
              </a:p>
            </p:txBody>
          </p:sp>
          <p:sp>
            <p:nvSpPr>
              <p:cNvPr id="28729" name="Rectangle 16"/>
              <p:cNvSpPr>
                <a:spLocks noChangeArrowheads="1"/>
              </p:cNvSpPr>
              <p:nvPr/>
            </p:nvSpPr>
            <p:spPr bwMode="auto">
              <a:xfrm>
                <a:off x="3656013" y="5414963"/>
                <a:ext cx="127000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N</a:t>
                </a:r>
                <a:endParaRPr lang="en-US"/>
              </a:p>
            </p:txBody>
          </p:sp>
          <p:sp>
            <p:nvSpPr>
              <p:cNvPr id="28730" name="Rectangle 17"/>
              <p:cNvSpPr>
                <a:spLocks noChangeArrowheads="1"/>
              </p:cNvSpPr>
              <p:nvPr/>
            </p:nvSpPr>
            <p:spPr bwMode="auto">
              <a:xfrm>
                <a:off x="1308100" y="5637213"/>
                <a:ext cx="715963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Cw*1701</a:t>
                </a:r>
                <a:endParaRPr lang="en-US"/>
              </a:p>
            </p:txBody>
          </p:sp>
          <p:sp>
            <p:nvSpPr>
              <p:cNvPr id="28731" name="Rectangle 18"/>
              <p:cNvSpPr>
                <a:spLocks noChangeArrowheads="1"/>
              </p:cNvSpPr>
              <p:nvPr/>
            </p:nvSpPr>
            <p:spPr bwMode="auto">
              <a:xfrm>
                <a:off x="2932113" y="5637213"/>
                <a:ext cx="115887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A</a:t>
                </a:r>
                <a:endParaRPr lang="en-US"/>
              </a:p>
            </p:txBody>
          </p:sp>
          <p:sp>
            <p:nvSpPr>
              <p:cNvPr id="28732" name="Rectangle 19"/>
              <p:cNvSpPr>
                <a:spLocks noChangeArrowheads="1"/>
              </p:cNvSpPr>
              <p:nvPr/>
            </p:nvSpPr>
            <p:spPr bwMode="auto">
              <a:xfrm>
                <a:off x="3656013" y="5637213"/>
                <a:ext cx="127000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N</a:t>
                </a:r>
                <a:endParaRPr lang="en-US"/>
              </a:p>
            </p:txBody>
          </p:sp>
          <p:sp>
            <p:nvSpPr>
              <p:cNvPr id="28733" name="Rectangle 20"/>
              <p:cNvSpPr>
                <a:spLocks noChangeArrowheads="1"/>
              </p:cNvSpPr>
              <p:nvPr/>
            </p:nvSpPr>
            <p:spPr bwMode="auto">
              <a:xfrm>
                <a:off x="1308100" y="5857875"/>
                <a:ext cx="715963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Cw*1802</a:t>
                </a:r>
                <a:endParaRPr lang="en-US"/>
              </a:p>
            </p:txBody>
          </p:sp>
          <p:sp>
            <p:nvSpPr>
              <p:cNvPr id="28734" name="Rectangle 21"/>
              <p:cNvSpPr>
                <a:spLocks noChangeArrowheads="1"/>
              </p:cNvSpPr>
              <p:nvPr/>
            </p:nvSpPr>
            <p:spPr bwMode="auto">
              <a:xfrm>
                <a:off x="2932113" y="5857875"/>
                <a:ext cx="115887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A</a:t>
                </a:r>
                <a:endParaRPr lang="en-US"/>
              </a:p>
            </p:txBody>
          </p:sp>
          <p:sp>
            <p:nvSpPr>
              <p:cNvPr id="28735" name="Rectangle 22"/>
              <p:cNvSpPr>
                <a:spLocks noChangeArrowheads="1"/>
              </p:cNvSpPr>
              <p:nvPr/>
            </p:nvSpPr>
            <p:spPr bwMode="auto">
              <a:xfrm>
                <a:off x="3656013" y="5857875"/>
                <a:ext cx="127000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FFFFFF"/>
                    </a:solidFill>
                  </a:rPr>
                  <a:t>N</a:t>
                </a:r>
                <a:endParaRPr lang="en-US"/>
              </a:p>
            </p:txBody>
          </p:sp>
          <p:sp>
            <p:nvSpPr>
              <p:cNvPr id="28736" name="Rectangle 23"/>
              <p:cNvSpPr>
                <a:spLocks noChangeArrowheads="1"/>
              </p:cNvSpPr>
              <p:nvPr/>
            </p:nvSpPr>
            <p:spPr bwMode="auto">
              <a:xfrm>
                <a:off x="1308100" y="6080125"/>
                <a:ext cx="715963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Cw*0702</a:t>
                </a:r>
                <a:endParaRPr lang="en-US"/>
              </a:p>
            </p:txBody>
          </p:sp>
          <p:sp>
            <p:nvSpPr>
              <p:cNvPr id="28737" name="Rectangle 24"/>
              <p:cNvSpPr>
                <a:spLocks noChangeArrowheads="1"/>
              </p:cNvSpPr>
              <p:nvPr/>
            </p:nvSpPr>
            <p:spPr bwMode="auto">
              <a:xfrm>
                <a:off x="2932113" y="6080125"/>
                <a:ext cx="115887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A</a:t>
                </a:r>
                <a:endParaRPr lang="en-US"/>
              </a:p>
            </p:txBody>
          </p:sp>
          <p:sp>
            <p:nvSpPr>
              <p:cNvPr id="28738" name="Rectangle 25"/>
              <p:cNvSpPr>
                <a:spLocks noChangeArrowheads="1"/>
              </p:cNvSpPr>
              <p:nvPr/>
            </p:nvSpPr>
            <p:spPr bwMode="auto">
              <a:xfrm>
                <a:off x="3660775" y="6080125"/>
                <a:ext cx="117475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S</a:t>
                </a:r>
                <a:endParaRPr lang="en-US"/>
              </a:p>
            </p:txBody>
          </p:sp>
          <p:sp>
            <p:nvSpPr>
              <p:cNvPr id="28739" name="Rectangle 26"/>
              <p:cNvSpPr>
                <a:spLocks noChangeArrowheads="1"/>
              </p:cNvSpPr>
              <p:nvPr/>
            </p:nvSpPr>
            <p:spPr bwMode="auto">
              <a:xfrm>
                <a:off x="2855913" y="4514850"/>
                <a:ext cx="1017587" cy="21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500">
                    <a:solidFill>
                      <a:srgbClr val="000000"/>
                    </a:solidFill>
                  </a:rPr>
                  <a:t>aa &amp; position</a:t>
                </a:r>
                <a:endParaRPr lang="en-US"/>
              </a:p>
            </p:txBody>
          </p:sp>
          <p:sp>
            <p:nvSpPr>
              <p:cNvPr id="28740" name="Line 34"/>
              <p:cNvSpPr>
                <a:spLocks noChangeShapeType="1"/>
              </p:cNvSpPr>
              <p:nvPr/>
            </p:nvSpPr>
            <p:spPr bwMode="auto">
              <a:xfrm>
                <a:off x="1268413" y="6291263"/>
                <a:ext cx="2811462" cy="15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41" name="Line 34"/>
              <p:cNvSpPr>
                <a:spLocks noChangeShapeType="1"/>
              </p:cNvSpPr>
              <p:nvPr/>
            </p:nvSpPr>
            <p:spPr bwMode="auto">
              <a:xfrm>
                <a:off x="1268413" y="5430838"/>
                <a:ext cx="281146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42" name="Line 34"/>
              <p:cNvSpPr>
                <a:spLocks noChangeShapeType="1"/>
              </p:cNvSpPr>
              <p:nvPr/>
            </p:nvSpPr>
            <p:spPr bwMode="auto">
              <a:xfrm>
                <a:off x="1268413" y="5645150"/>
                <a:ext cx="2811462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43" name="Line 34"/>
              <p:cNvSpPr>
                <a:spLocks noChangeShapeType="1"/>
              </p:cNvSpPr>
              <p:nvPr/>
            </p:nvSpPr>
            <p:spPr bwMode="auto">
              <a:xfrm>
                <a:off x="1268413" y="5861050"/>
                <a:ext cx="2811462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44" name="Line 34"/>
              <p:cNvSpPr>
                <a:spLocks noChangeShapeType="1"/>
              </p:cNvSpPr>
              <p:nvPr/>
            </p:nvSpPr>
            <p:spPr bwMode="auto">
              <a:xfrm>
                <a:off x="1268413" y="6054725"/>
                <a:ext cx="2811462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45" name="Line 34"/>
              <p:cNvSpPr>
                <a:spLocks noChangeShapeType="1"/>
              </p:cNvSpPr>
              <p:nvPr/>
            </p:nvSpPr>
            <p:spPr bwMode="auto">
              <a:xfrm>
                <a:off x="1268413" y="5165725"/>
                <a:ext cx="2811462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28677" name="TextBox 50"/>
            <p:cNvSpPr txBox="1">
              <a:spLocks noChangeArrowheads="1"/>
            </p:cNvSpPr>
            <p:nvPr/>
          </p:nvSpPr>
          <p:spPr bwMode="auto">
            <a:xfrm>
              <a:off x="4572000" y="4876800"/>
              <a:ext cx="609600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600">
                  <a:solidFill>
                    <a:schemeClr val="bg1"/>
                  </a:solidFill>
                </a:rPr>
                <a:t>77N</a:t>
              </a:r>
            </a:p>
            <a:p>
              <a:r>
                <a:rPr lang="en-US" sz="1600">
                  <a:solidFill>
                    <a:schemeClr val="bg1"/>
                  </a:solidFill>
                </a:rPr>
                <a:t>73A</a:t>
              </a:r>
            </a:p>
          </p:txBody>
        </p:sp>
      </p:grp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0"/>
            <a:ext cx="9144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G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5037 shared by the HLA C-locus antigens Cw4, Cw6, Cw17, Cw18 and defined by 73A+77N. Antibody reaction strength increases with the unobstructed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after removal of the peptide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1</Words>
  <Application>Microsoft Office PowerPoint</Application>
  <PresentationFormat>On-screen Show (4:3)</PresentationFormat>
  <Paragraphs>5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4:12:22Z</dcterms:created>
  <dcterms:modified xsi:type="dcterms:W3CDTF">2017-03-12T17:18:33Z</dcterms:modified>
</cp:coreProperties>
</file>